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712"/>
  </p:normalViewPr>
  <p:slideViewPr>
    <p:cSldViewPr snapToGrid="0" snapToObjects="1">
      <p:cViewPr varScale="1">
        <p:scale>
          <a:sx n="105" d="100"/>
          <a:sy n="105" d="100"/>
        </p:scale>
        <p:origin x="7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0A2E5-AC0F-064B-9991-510C12CDD2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1D0CED-79EB-2E44-9C2E-BE3E5EAFF0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289D26-9B9E-A64E-A7D6-51B1B47FE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1E73F3-65B1-9D44-A540-2EFF06B3D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531F5D-3D30-0546-9B7E-376950D8F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33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EFA4F-D060-7A46-9ACC-37140B756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E56A42-E534-034D-8243-E3ECE60F2F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545441-21AE-D44D-BAB0-C912685A3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1329FA-7275-744D-B65C-D87ABA047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5FCD18-09A0-574B-8B43-88E72B89F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672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2FA1B6-232C-3140-BA99-5F22312CDF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37E45D-A8FB-F748-BE90-D6DCBB6C4F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C6EC75-AF62-0941-A650-7DB43B60C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97C7A9-0431-2942-A5C1-B37C692E8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66B6-3F97-6A4D-81FC-97C65A946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97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9F07D-F385-5442-80DC-40B83F3C3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C3C7DD-28F8-EF4A-A838-10B9ED1263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4477D-5480-2549-AEF3-AFEE3F0CB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B54AC4-72FE-624A-B786-EA913A8E0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B6BD44-99AD-874F-961C-FE4F818E4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7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84C599-8BDF-8A4E-8005-AEFF3DFE0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8C719-DCFD-A74F-AA44-7358058E31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B25D34-1182-EC41-9A4E-9614063E8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0D1EB9-0673-1C4F-861A-C88520C1B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4C93F6-CC99-FE49-BA2B-7711E97B22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067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73A78-2C20-5747-9EA3-FE54331AD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144377-8030-9F42-BA7A-C04D0084FA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DD6AA7-75B9-D745-93EF-32218705E6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FB5F18-0F79-494D-A8A2-12A07AF49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8807ED-CEAB-7F40-8072-67C19D79F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6AA261-8AA8-7B47-BC35-A7EE85577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108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F146EB-49EA-6248-A85B-3C1263EB6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FAE774-D6F5-E24E-A27C-A8606625D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9DEF2A-38C0-9946-81C8-7BDE487B5D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E89E4E-D21C-3041-B9FF-987215F09E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9E667E-F90A-5C46-B84F-6CEF75F0B8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DECBE1-0F63-254F-9013-292A7BE15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4865A8-156D-6D4A-84C1-0301AAB6C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B246DF-8DB8-6C4E-9ED4-9085E3905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899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A32C6-D791-E846-BFD7-ADFF8E994E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6C26E7-20E7-B140-85D2-C382C7DA5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DF4FE2-60F5-0944-ADEB-3C9A2468C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6861D2-6EE5-3342-9799-E8B3555A5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128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28A3B8-7BAA-7542-A8FD-B7E4EBC27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153B0F-A895-1C48-A2D1-80B1CF4E6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0D3272-7D45-084D-8AA2-59450C275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95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003F98-0241-1845-88C0-B902FB831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F36A1D-0A4B-314F-8D34-C445537707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9A8A96-2855-E445-87A0-C8E7268224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1B12AF-7D34-E646-9A0B-6A9A257A3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C809B8-AABF-3A44-96D8-8585E3C62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1F2BA7-B2B2-E849-AD50-281058955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475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48A26-601E-BC4B-91EC-BA6E24D45A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76430E-159E-754E-9177-C30056D596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5EA898-11E7-7D4F-96AD-4E7F0734C7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392EB6-6446-384A-82DC-34C98EB59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09EE8B-7F40-A243-9B0A-85F7F5173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2CF2CF-D131-FC44-AE35-F97F2FE56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029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2F7A6E-03B5-8443-968D-94C0DF10B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C02450-A76B-574D-8EE9-04E42147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569F5-46AA-CD4D-8073-10BCFF9041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EB28C-2A95-E344-9A37-1BF5458FF20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CE5D06-DD52-D646-B49B-3915547850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6AB79-2A29-F045-A7E0-03EA6F08F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0062A-CD44-6947-81F1-B12D1007E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562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143" y="1103532"/>
            <a:ext cx="12046857" cy="56984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2238829" y="210458"/>
            <a:ext cx="7239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: Protein ID’s with % total spectral counts/gel band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4-6 MW fraction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eL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examples as per Figure 2) </a:t>
            </a:r>
          </a:p>
        </p:txBody>
      </p:sp>
    </p:spTree>
    <p:extLst>
      <p:ext uri="{BB962C8B-B14F-4D97-AF65-F5344CB8AC3E}">
        <p14:creationId xmlns:p14="http://schemas.microsoft.com/office/powerpoint/2010/main" val="3278327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4</cp:revision>
  <cp:lastPrinted>2020-10-02T21:49:34Z</cp:lastPrinted>
  <dcterms:created xsi:type="dcterms:W3CDTF">2020-08-04T23:55:27Z</dcterms:created>
  <dcterms:modified xsi:type="dcterms:W3CDTF">2020-10-02T21:49:36Z</dcterms:modified>
</cp:coreProperties>
</file>